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574440-4CB5-4CBF-A861-BBFB207BC55F}" v="1" dt="2022-06-21T16:13:04.8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>
      <p:cViewPr varScale="1">
        <p:scale>
          <a:sx n="91" d="100"/>
          <a:sy n="91" d="100"/>
        </p:scale>
        <p:origin x="208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imone Badal" userId="0fe51a2c2694c397" providerId="Windows Live" clId="Web-{BF574440-4CB5-4CBF-A861-BBFB207BC55F}"/>
    <pc:docChg chg="modSld">
      <pc:chgData name="Simone Badal" userId="0fe51a2c2694c397" providerId="Windows Live" clId="Web-{BF574440-4CB5-4CBF-A861-BBFB207BC55F}" dt="2022-06-21T16:13:04.873" v="0" actId="14100"/>
      <pc:docMkLst>
        <pc:docMk/>
      </pc:docMkLst>
      <pc:sldChg chg="modSp">
        <pc:chgData name="Simone Badal" userId="0fe51a2c2694c397" providerId="Windows Live" clId="Web-{BF574440-4CB5-4CBF-A861-BBFB207BC55F}" dt="2022-06-21T16:13:04.873" v="0" actId="14100"/>
        <pc:sldMkLst>
          <pc:docMk/>
          <pc:sldMk cId="2595397047" sldId="259"/>
        </pc:sldMkLst>
        <pc:spChg chg="mod">
          <ac:chgData name="Simone Badal" userId="0fe51a2c2694c397" providerId="Windows Live" clId="Web-{BF574440-4CB5-4CBF-A861-BBFB207BC55F}" dt="2022-06-21T16:13:04.873" v="0" actId="14100"/>
          <ac:spMkLst>
            <pc:docMk/>
            <pc:sldMk cId="2595397047" sldId="259"/>
            <ac:spMk id="4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672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050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698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356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834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876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34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281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266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714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233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D40198-95E0-4270-BC08-532630957E31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3ECD2-F3C5-47BA-A365-8A4CCBDA2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676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2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12" Type="http://schemas.openxmlformats.org/officeDocument/2006/relationships/image" Target="../media/image21.pn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Relationship Id="rId14" Type="http://schemas.openxmlformats.org/officeDocument/2006/relationships/image" Target="../media/image2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0" Type="http://schemas.openxmlformats.org/officeDocument/2006/relationships/image" Target="../media/image32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Relationship Id="rId14" Type="http://schemas.openxmlformats.org/officeDocument/2006/relationships/image" Target="../media/image3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SUR19-7896 HE High Gleason Perineural Infiltration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95" y="356430"/>
            <a:ext cx="2551176" cy="1911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 descr="SUR19-7896 CD44 20x Tumor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493" y="2383019"/>
            <a:ext cx="2551176" cy="1911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 descr="C:\Users\harrissr\AppData\Local\Microsoft\Windows\INetCache\Content.Word\SUR19-7896 CD44 Control 4x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95" y="2383019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 descr="C:\Users\harrissr\AppData\Local\Microsoft\Windows\INetCache\Content.Word\SUR19-7896 c-MYC 20x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493" y="4423409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8" name="Picture 4" descr="SUR19-7896 c-MYC Control 4x"/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95" y="4409608"/>
            <a:ext cx="2551176" cy="1911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 descr="SUR19-7896 Ki67 Control 4x"/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92384" y="328830"/>
            <a:ext cx="2551176" cy="1911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11" descr="C:\Users\harrissr\AppData\Local\Microsoft\Windows\INetCache\Content.Word\SUR19-7896 MUC1 20xPositive.jpg"/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79381" y="2397160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 descr="C:\Users\harrissr\AppData\Local\Microsoft\Windows\INetCache\Content.Word\SUR19-7896 MUC1 Control 4x.jpg"/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92384" y="2373570"/>
            <a:ext cx="2551176" cy="1911096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 3"/>
          <p:cNvSpPr/>
          <p:nvPr/>
        </p:nvSpPr>
        <p:spPr>
          <a:xfrm>
            <a:off x="55799" y="3183431"/>
            <a:ext cx="5741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4</a:t>
            </a:r>
            <a:endParaRPr lang="en-US" sz="1400" dirty="0"/>
          </a:p>
        </p:txBody>
      </p:sp>
      <p:sp>
        <p:nvSpPr>
          <p:cNvPr id="6" name="Rectangle 5"/>
          <p:cNvSpPr/>
          <p:nvPr/>
        </p:nvSpPr>
        <p:spPr>
          <a:xfrm>
            <a:off x="55799" y="5210020"/>
            <a:ext cx="69333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-MYC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600" dirty="0"/>
          </a:p>
        </p:txBody>
      </p:sp>
      <p:sp>
        <p:nvSpPr>
          <p:cNvPr id="9" name="Rectangle 8"/>
          <p:cNvSpPr/>
          <p:nvPr/>
        </p:nvSpPr>
        <p:spPr>
          <a:xfrm>
            <a:off x="6343836" y="1113494"/>
            <a:ext cx="5485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i67</a:t>
            </a:r>
            <a:endParaRPr lang="en-US" sz="1400" dirty="0"/>
          </a:p>
        </p:txBody>
      </p:sp>
      <p:sp>
        <p:nvSpPr>
          <p:cNvPr id="11" name="Rectangle 10"/>
          <p:cNvSpPr/>
          <p:nvPr/>
        </p:nvSpPr>
        <p:spPr>
          <a:xfrm>
            <a:off x="6313333" y="3198819"/>
            <a:ext cx="8408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CI</a:t>
            </a:r>
            <a:endParaRPr lang="en-US" sz="1400" dirty="0"/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878464" y="4395809"/>
            <a:ext cx="2627604" cy="1938696"/>
          </a:xfrm>
          <a:prstGeom prst="rect">
            <a:avLst/>
          </a:prstGeom>
        </p:spPr>
      </p:pic>
      <p:sp>
        <p:nvSpPr>
          <p:cNvPr id="39" name="Rectangle 38"/>
          <p:cNvSpPr/>
          <p:nvPr/>
        </p:nvSpPr>
        <p:spPr>
          <a:xfrm>
            <a:off x="194832" y="1206530"/>
            <a:ext cx="38504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</a:t>
            </a:r>
            <a:endParaRPr lang="en-US" sz="14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564396" y="325616"/>
            <a:ext cx="2548349" cy="191431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9393042" y="5182080"/>
            <a:ext cx="16475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Synaptho-physin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582283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41435" y="2769723"/>
            <a:ext cx="2539666" cy="190475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146572" y="3592541"/>
            <a:ext cx="82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16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81502" y="5606428"/>
            <a:ext cx="82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27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179256" y="1555973"/>
            <a:ext cx="82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53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056167" y="3612108"/>
            <a:ext cx="9826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HG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92041" y="1578654"/>
            <a:ext cx="82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HE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247" y="706464"/>
            <a:ext cx="2633700" cy="190821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5536" y="2775283"/>
            <a:ext cx="2615411" cy="191431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4791" y="4772463"/>
            <a:ext cx="2712955" cy="1908213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50501" y="2774917"/>
            <a:ext cx="2682472" cy="1908213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39505" y="756792"/>
            <a:ext cx="2682472" cy="1908213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23192" y="695121"/>
            <a:ext cx="2560542" cy="1914310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321027" y="4587725"/>
            <a:ext cx="438770" cy="57231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11325770" y="4492313"/>
            <a:ext cx="409514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" b="1" dirty="0"/>
              <a:t>100 µm</a:t>
            </a: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313376" y="2787476"/>
            <a:ext cx="2542252" cy="1902117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09263" y="4784289"/>
            <a:ext cx="2542252" cy="1902117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321977" y="755756"/>
            <a:ext cx="2548349" cy="1908213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6179256" y="5482543"/>
            <a:ext cx="920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R</a:t>
            </a: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650501" y="4751043"/>
            <a:ext cx="2548349" cy="1908213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341435" y="4751043"/>
            <a:ext cx="2548349" cy="1908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134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2544" y="4311014"/>
            <a:ext cx="2548131" cy="191109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538593" y="1240493"/>
            <a:ext cx="660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63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02172" y="3231003"/>
            <a:ext cx="920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KX3.1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50760" y="1271847"/>
            <a:ext cx="920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S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329095" y="3257288"/>
            <a:ext cx="7903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K8-18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6018200" y="5087960"/>
            <a:ext cx="11522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E-Cadherin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30490" y="5993518"/>
            <a:ext cx="445047" cy="152413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1684" y="405797"/>
            <a:ext cx="2548349" cy="190821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8526" y="2396704"/>
            <a:ext cx="2548349" cy="191431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16162" y="2402081"/>
            <a:ext cx="2548349" cy="1908213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99320" y="405797"/>
            <a:ext cx="2548349" cy="1914310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64613" y="342900"/>
            <a:ext cx="2548349" cy="1914310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630289" y="4307802"/>
            <a:ext cx="2548349" cy="191431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630289" y="2315667"/>
            <a:ext cx="2548349" cy="1908213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964612" y="2340494"/>
            <a:ext cx="2548349" cy="1908213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624193" y="311374"/>
            <a:ext cx="2554445" cy="1920406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43271" y="5190159"/>
            <a:ext cx="9826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IN4</a:t>
            </a: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58526" y="4387361"/>
            <a:ext cx="2639797" cy="190821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522259" y="4381264"/>
            <a:ext cx="2542252" cy="19143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66036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46847" y="374319"/>
            <a:ext cx="10957064" cy="11212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l Figure 2: 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HC staining on original patient tissue from which ACRJ-PC28 was derived. Tissue sample was obtained from a transrectal needle biopsy of the prostate gland of a patient with PSA levels of ~420 ng/</a:t>
            </a:r>
            <a:r>
              <a:rPr lang="en-US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l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sz="16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5397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8</TotalTime>
  <Words>63</Words>
  <Application>Microsoft Macintosh PowerPoint</Application>
  <PresentationFormat>Widescreen</PresentationFormat>
  <Paragraphs>2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e, Henkel L</dc:creator>
  <cp:lastModifiedBy>Simone Badal</cp:lastModifiedBy>
  <cp:revision>33</cp:revision>
  <dcterms:created xsi:type="dcterms:W3CDTF">2022-05-15T15:33:11Z</dcterms:created>
  <dcterms:modified xsi:type="dcterms:W3CDTF">2022-06-23T13:48:06Z</dcterms:modified>
</cp:coreProperties>
</file>